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4A10220-20F0-4C4D-859F-6D66703ADCC5}" v="4" dt="2023-03-28T03:25:45.21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9074" autoAdjust="0"/>
  </p:normalViewPr>
  <p:slideViewPr>
    <p:cSldViewPr snapToGrid="0">
      <p:cViewPr varScale="1">
        <p:scale>
          <a:sx n="108" d="100"/>
          <a:sy n="108" d="100"/>
        </p:scale>
        <p:origin x="6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박 성균" userId="475b0f278f8dc192" providerId="LiveId" clId="{C27AC8A4-F973-44B3-B8C0-14CEF9C4B857}"/>
    <pc:docChg chg="undo custSel addSld modSld">
      <pc:chgData name="박 성균" userId="475b0f278f8dc192" providerId="LiveId" clId="{C27AC8A4-F973-44B3-B8C0-14CEF9C4B857}" dt="2023-02-20T09:31:09.435" v="234" actId="680"/>
      <pc:docMkLst>
        <pc:docMk/>
      </pc:docMkLst>
      <pc:sldChg chg="addSp modSp mod">
        <pc:chgData name="박 성균" userId="475b0f278f8dc192" providerId="LiveId" clId="{C27AC8A4-F973-44B3-B8C0-14CEF9C4B857}" dt="2023-02-20T08:19:59.896" v="23" actId="164"/>
        <pc:sldMkLst>
          <pc:docMk/>
          <pc:sldMk cId="4146746184" sldId="257"/>
        </pc:sldMkLst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5" creationId="{11E51F27-A109-B610-3C90-529B9AC6FC8D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6" creationId="{216FA059-8F9A-48E0-C0D0-C0B61B57277C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7" creationId="{251C2E4C-68D0-0CE9-6919-1DD3FF8892F7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8" creationId="{0DA76F23-98A3-FF9D-F7A4-18AB5EB1892D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9" creationId="{D83AE84C-B419-2FCD-DEAE-89D828B34FE0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10" creationId="{84DD82ED-7BD8-56E3-6F78-F99E604C4A57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17" creationId="{917716E8-9E6D-A09B-5997-7A88997036D5}"/>
          </ac:spMkLst>
        </pc:spChg>
        <pc:spChg chg="mod">
          <ac:chgData name="박 성균" userId="475b0f278f8dc192" providerId="LiveId" clId="{C27AC8A4-F973-44B3-B8C0-14CEF9C4B857}" dt="2023-02-20T08:19:59.896" v="23" actId="164"/>
          <ac:spMkLst>
            <pc:docMk/>
            <pc:sldMk cId="4146746184" sldId="257"/>
            <ac:spMk id="22" creationId="{18E77BDD-706D-BA92-98C5-D163BDFA5204}"/>
          </ac:spMkLst>
        </pc:spChg>
        <pc:grpChg chg="add mod">
          <ac:chgData name="박 성균" userId="475b0f278f8dc192" providerId="LiveId" clId="{C27AC8A4-F973-44B3-B8C0-14CEF9C4B857}" dt="2023-02-20T08:19:59.896" v="23" actId="164"/>
          <ac:grpSpMkLst>
            <pc:docMk/>
            <pc:sldMk cId="4146746184" sldId="257"/>
            <ac:grpSpMk id="4" creationId="{831EAA7E-9FDB-BF47-1C5F-757A9919B462}"/>
          </ac:grpSpMkLst>
        </pc:grp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12" creationId="{E3C3EC02-8FC9-E767-2954-5A89A2522272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13" creationId="{45FB00E6-8B90-14A0-2F1C-435C821CE8B0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15" creationId="{E7F6253D-4482-D92B-101D-5B9DA72731C5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16" creationId="{E932FE73-497B-636C-FD0B-187F52A907C0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19" creationId="{A512CA49-723B-ADF9-81B8-ACC16F29D0E5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21" creationId="{392EE18C-B7A4-9A91-6C6D-BB39955C0F37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30" creationId="{E91F082B-FE65-C769-5F18-455257CF570E}"/>
          </ac:cxnSpMkLst>
        </pc:cxnChg>
        <pc:cxnChg chg="mod">
          <ac:chgData name="박 성균" userId="475b0f278f8dc192" providerId="LiveId" clId="{C27AC8A4-F973-44B3-B8C0-14CEF9C4B857}" dt="2023-02-20T08:19:59.896" v="23" actId="164"/>
          <ac:cxnSpMkLst>
            <pc:docMk/>
            <pc:sldMk cId="4146746184" sldId="257"/>
            <ac:cxnSpMk id="33" creationId="{B180B879-6AB7-9D52-37B9-2B26A1B2625D}"/>
          </ac:cxnSpMkLst>
        </pc:cxnChg>
      </pc:sldChg>
      <pc:sldChg chg="addSp delSp modSp new mod">
        <pc:chgData name="박 성균" userId="475b0f278f8dc192" providerId="LiveId" clId="{C27AC8A4-F973-44B3-B8C0-14CEF9C4B857}" dt="2023-02-20T09:20:59.260" v="168" actId="164"/>
        <pc:sldMkLst>
          <pc:docMk/>
          <pc:sldMk cId="1372664160" sldId="258"/>
        </pc:sldMkLst>
        <pc:spChg chg="del">
          <ac:chgData name="박 성균" userId="475b0f278f8dc192" providerId="LiveId" clId="{C27AC8A4-F973-44B3-B8C0-14CEF9C4B857}" dt="2023-02-20T09:16:34.409" v="26" actId="478"/>
          <ac:spMkLst>
            <pc:docMk/>
            <pc:sldMk cId="1372664160" sldId="258"/>
            <ac:spMk id="2" creationId="{1F0E40C5-9D5A-0509-0980-8863298ED762}"/>
          </ac:spMkLst>
        </pc:spChg>
        <pc:spChg chg="del">
          <ac:chgData name="박 성균" userId="475b0f278f8dc192" providerId="LiveId" clId="{C27AC8A4-F973-44B3-B8C0-14CEF9C4B857}" dt="2023-02-20T09:16:33.954" v="25" actId="478"/>
          <ac:spMkLst>
            <pc:docMk/>
            <pc:sldMk cId="1372664160" sldId="258"/>
            <ac:spMk id="3" creationId="{C8C786BF-09F0-636F-E9AC-CA41BBEF4658}"/>
          </ac:spMkLst>
        </pc:spChg>
        <pc:spChg chg="add del mod">
          <ac:chgData name="박 성균" userId="475b0f278f8dc192" providerId="LiveId" clId="{C27AC8A4-F973-44B3-B8C0-14CEF9C4B857}" dt="2023-02-20T09:17:05.976" v="40" actId="478"/>
          <ac:spMkLst>
            <pc:docMk/>
            <pc:sldMk cId="1372664160" sldId="258"/>
            <ac:spMk id="8" creationId="{3948E451-B2FE-EF19-A24A-95DC911AE3FC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9" creationId="{67998FE7-D7E8-AB5E-295B-6DA2993B6278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0" creationId="{9964407D-F54D-ECD1-48FA-BF2FC9231478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1" creationId="{48E182F9-9BED-0261-65DD-DAE749680F8E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2" creationId="{147A8D4A-1885-A771-E7EE-9AB71FD428EC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3" creationId="{254545BF-9A58-46B3-C0B3-C740CC454D05}"/>
          </ac:spMkLst>
        </pc:spChg>
        <pc:spChg chg="add del mod">
          <ac:chgData name="박 성균" userId="475b0f278f8dc192" providerId="LiveId" clId="{C27AC8A4-F973-44B3-B8C0-14CEF9C4B857}" dt="2023-02-20T09:19:06.531" v="119"/>
          <ac:spMkLst>
            <pc:docMk/>
            <pc:sldMk cId="1372664160" sldId="258"/>
            <ac:spMk id="14" creationId="{11DD180F-78F9-E3DA-2E2B-A74704B0173D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5" creationId="{4D493237-9124-250B-89F2-DE0DB8F83DEB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6" creationId="{8326A8F0-3E3B-A548-E8AF-5A5D4453F3E8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7" creationId="{0DB2E339-EA29-591E-6A77-19385516D04C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8" creationId="{DB728294-94F9-4B1E-84A9-A1BA829E5BEE}"/>
          </ac:spMkLst>
        </pc:spChg>
        <pc:spChg chg="add mod">
          <ac:chgData name="박 성균" userId="475b0f278f8dc192" providerId="LiveId" clId="{C27AC8A4-F973-44B3-B8C0-14CEF9C4B857}" dt="2023-02-20T09:20:59.260" v="168" actId="164"/>
          <ac:spMkLst>
            <pc:docMk/>
            <pc:sldMk cId="1372664160" sldId="258"/>
            <ac:spMk id="19" creationId="{61835A0F-FD1B-C1AE-1C6E-094BD0F15838}"/>
          </ac:spMkLst>
        </pc:spChg>
        <pc:grpChg chg="add mod">
          <ac:chgData name="박 성균" userId="475b0f278f8dc192" providerId="LiveId" clId="{C27AC8A4-F973-44B3-B8C0-14CEF9C4B857}" dt="2023-02-20T09:20:59.260" v="168" actId="164"/>
          <ac:grpSpMkLst>
            <pc:docMk/>
            <pc:sldMk cId="1372664160" sldId="258"/>
            <ac:grpSpMk id="20" creationId="{E777A518-0016-537D-1A0C-C13167AFAA73}"/>
          </ac:grpSpMkLst>
        </pc:grpChg>
        <pc:picChg chg="add mod">
          <ac:chgData name="박 성균" userId="475b0f278f8dc192" providerId="LiveId" clId="{C27AC8A4-F973-44B3-B8C0-14CEF9C4B857}" dt="2023-02-20T09:20:59.260" v="168" actId="164"/>
          <ac:picMkLst>
            <pc:docMk/>
            <pc:sldMk cId="1372664160" sldId="258"/>
            <ac:picMk id="4" creationId="{6E7278AF-A251-D85E-4678-69D38BDE0241}"/>
          </ac:picMkLst>
        </pc:picChg>
        <pc:picChg chg="add mod">
          <ac:chgData name="박 성균" userId="475b0f278f8dc192" providerId="LiveId" clId="{C27AC8A4-F973-44B3-B8C0-14CEF9C4B857}" dt="2023-02-20T09:20:59.260" v="168" actId="164"/>
          <ac:picMkLst>
            <pc:docMk/>
            <pc:sldMk cId="1372664160" sldId="258"/>
            <ac:picMk id="5" creationId="{2F88C1F7-848B-213E-83AD-DA03B6FBB62C}"/>
          </ac:picMkLst>
        </pc:picChg>
        <pc:picChg chg="add mod">
          <ac:chgData name="박 성균" userId="475b0f278f8dc192" providerId="LiveId" clId="{C27AC8A4-F973-44B3-B8C0-14CEF9C4B857}" dt="2023-02-20T09:20:59.260" v="168" actId="164"/>
          <ac:picMkLst>
            <pc:docMk/>
            <pc:sldMk cId="1372664160" sldId="258"/>
            <ac:picMk id="6" creationId="{DF2C59BF-C431-E00C-2D57-6F123D1349BC}"/>
          </ac:picMkLst>
        </pc:picChg>
        <pc:picChg chg="add mod">
          <ac:chgData name="박 성균" userId="475b0f278f8dc192" providerId="LiveId" clId="{C27AC8A4-F973-44B3-B8C0-14CEF9C4B857}" dt="2023-02-20T09:20:59.260" v="168" actId="164"/>
          <ac:picMkLst>
            <pc:docMk/>
            <pc:sldMk cId="1372664160" sldId="258"/>
            <ac:picMk id="7" creationId="{B699135D-685F-DC9C-45BB-ACCABC0133BF}"/>
          </ac:picMkLst>
        </pc:picChg>
      </pc:sldChg>
      <pc:sldChg chg="addSp delSp modSp new mod">
        <pc:chgData name="박 성균" userId="475b0f278f8dc192" providerId="LiveId" clId="{C27AC8A4-F973-44B3-B8C0-14CEF9C4B857}" dt="2023-02-20T09:27:44.757" v="233" actId="164"/>
        <pc:sldMkLst>
          <pc:docMk/>
          <pc:sldMk cId="2027816751" sldId="259"/>
        </pc:sldMkLst>
        <pc:spChg chg="del">
          <ac:chgData name="박 성균" userId="475b0f278f8dc192" providerId="LiveId" clId="{C27AC8A4-F973-44B3-B8C0-14CEF9C4B857}" dt="2023-02-20T09:24:30.422" v="170" actId="478"/>
          <ac:spMkLst>
            <pc:docMk/>
            <pc:sldMk cId="2027816751" sldId="259"/>
            <ac:spMk id="2" creationId="{EE6828DF-DB5B-A9BA-A5E6-8E9275C67D04}"/>
          </ac:spMkLst>
        </pc:spChg>
        <pc:spChg chg="del">
          <ac:chgData name="박 성균" userId="475b0f278f8dc192" providerId="LiveId" clId="{C27AC8A4-F973-44B3-B8C0-14CEF9C4B857}" dt="2023-02-20T09:24:31.358" v="171" actId="478"/>
          <ac:spMkLst>
            <pc:docMk/>
            <pc:sldMk cId="2027816751" sldId="259"/>
            <ac:spMk id="3" creationId="{1C579EF0-68E4-E307-D29D-AC92B91BFE18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6" creationId="{6E333172-0DD3-9D51-A44F-7532E95EE3B7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7" creationId="{4077F019-4749-42AF-3D3E-C706202E080A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8" creationId="{617E52E8-9A3C-E387-F66F-FAB19D161670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9" creationId="{FA4F8B50-2A27-B164-A726-6FF2733B46E0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10" creationId="{C9146572-1E16-995B-DA8D-582F16A5DB93}"/>
          </ac:spMkLst>
        </pc:spChg>
        <pc:spChg chg="add mod">
          <ac:chgData name="박 성균" userId="475b0f278f8dc192" providerId="LiveId" clId="{C27AC8A4-F973-44B3-B8C0-14CEF9C4B857}" dt="2023-02-20T09:27:44.757" v="233" actId="164"/>
          <ac:spMkLst>
            <pc:docMk/>
            <pc:sldMk cId="2027816751" sldId="259"/>
            <ac:spMk id="11" creationId="{A25E5830-960C-B496-70C1-16ADC1811E03}"/>
          </ac:spMkLst>
        </pc:spChg>
        <pc:grpChg chg="add mod">
          <ac:chgData name="박 성균" userId="475b0f278f8dc192" providerId="LiveId" clId="{C27AC8A4-F973-44B3-B8C0-14CEF9C4B857}" dt="2023-02-20T09:27:44.757" v="233" actId="164"/>
          <ac:grpSpMkLst>
            <pc:docMk/>
            <pc:sldMk cId="2027816751" sldId="259"/>
            <ac:grpSpMk id="12" creationId="{27BBBC0C-7FFD-5290-4766-346CAA5FE502}"/>
          </ac:grpSpMkLst>
        </pc:grpChg>
        <pc:picChg chg="add mod">
          <ac:chgData name="박 성균" userId="475b0f278f8dc192" providerId="LiveId" clId="{C27AC8A4-F973-44B3-B8C0-14CEF9C4B857}" dt="2023-02-20T09:27:44.757" v="233" actId="164"/>
          <ac:picMkLst>
            <pc:docMk/>
            <pc:sldMk cId="2027816751" sldId="259"/>
            <ac:picMk id="4" creationId="{2F321A42-9AB5-5344-0772-508F264B9042}"/>
          </ac:picMkLst>
        </pc:picChg>
        <pc:picChg chg="add mod">
          <ac:chgData name="박 성균" userId="475b0f278f8dc192" providerId="LiveId" clId="{C27AC8A4-F973-44B3-B8C0-14CEF9C4B857}" dt="2023-02-20T09:27:44.757" v="233" actId="164"/>
          <ac:picMkLst>
            <pc:docMk/>
            <pc:sldMk cId="2027816751" sldId="259"/>
            <ac:picMk id="5" creationId="{6A266D6E-E278-8EB7-8E00-71C79F0FE30D}"/>
          </ac:picMkLst>
        </pc:picChg>
      </pc:sldChg>
      <pc:sldChg chg="new">
        <pc:chgData name="박 성균" userId="475b0f278f8dc192" providerId="LiveId" clId="{C27AC8A4-F973-44B3-B8C0-14CEF9C4B857}" dt="2023-02-20T09:31:09.435" v="234" actId="680"/>
        <pc:sldMkLst>
          <pc:docMk/>
          <pc:sldMk cId="3712454426" sldId="260"/>
        </pc:sldMkLst>
      </pc:sldChg>
    </pc:docChg>
  </pc:docChgLst>
  <pc:docChgLst>
    <pc:chgData name="박 성균" userId="475b0f278f8dc192" providerId="LiveId" clId="{64A10220-20F0-4C4D-859F-6D66703ADCC5}"/>
    <pc:docChg chg="modSld">
      <pc:chgData name="박 성균" userId="475b0f278f8dc192" providerId="LiveId" clId="{64A10220-20F0-4C4D-859F-6D66703ADCC5}" dt="2023-06-07T01:40:12.226" v="9" actId="20577"/>
      <pc:docMkLst>
        <pc:docMk/>
      </pc:docMkLst>
      <pc:sldChg chg="modSp mod">
        <pc:chgData name="박 성균" userId="475b0f278f8dc192" providerId="LiveId" clId="{64A10220-20F0-4C4D-859F-6D66703ADCC5}" dt="2023-06-07T01:40:12.226" v="9" actId="20577"/>
        <pc:sldMkLst>
          <pc:docMk/>
          <pc:sldMk cId="3712454426" sldId="260"/>
        </pc:sldMkLst>
        <pc:spChg chg="mod">
          <ac:chgData name="박 성균" userId="475b0f278f8dc192" providerId="LiveId" clId="{64A10220-20F0-4C4D-859F-6D66703ADCC5}" dt="2023-06-07T01:40:12.226" v="9" actId="20577"/>
          <ac:spMkLst>
            <pc:docMk/>
            <pc:sldMk cId="3712454426" sldId="260"/>
            <ac:spMk id="2" creationId="{5A59C6DD-A0F0-D1D6-6044-33AA70A95092}"/>
          </ac:spMkLst>
        </pc:spChg>
      </pc:sldChg>
    </pc:docChg>
  </pc:docChgLst>
  <pc:docChgLst>
    <pc:chgData name="박 성균" userId="475b0f278f8dc192" providerId="LiveId" clId="{700B3B1A-3C87-49B6-A18E-E54677178854}"/>
    <pc:docChg chg="custSel delSld modSld">
      <pc:chgData name="박 성균" userId="475b0f278f8dc192" providerId="LiveId" clId="{700B3B1A-3C87-49B6-A18E-E54677178854}" dt="2023-02-23T05:53:22.099" v="153" actId="1076"/>
      <pc:docMkLst>
        <pc:docMk/>
      </pc:docMkLst>
      <pc:sldChg chg="del">
        <pc:chgData name="박 성균" userId="475b0f278f8dc192" providerId="LiveId" clId="{700B3B1A-3C87-49B6-A18E-E54677178854}" dt="2023-02-23T05:52:51.807" v="147" actId="2696"/>
        <pc:sldMkLst>
          <pc:docMk/>
          <pc:sldMk cId="1290401223" sldId="256"/>
        </pc:sldMkLst>
      </pc:sldChg>
      <pc:sldChg chg="del">
        <pc:chgData name="박 성균" userId="475b0f278f8dc192" providerId="LiveId" clId="{700B3B1A-3C87-49B6-A18E-E54677178854}" dt="2023-02-20T09:31:57.954" v="0" actId="47"/>
        <pc:sldMkLst>
          <pc:docMk/>
          <pc:sldMk cId="4146746184" sldId="257"/>
        </pc:sldMkLst>
      </pc:sldChg>
      <pc:sldChg chg="del">
        <pc:chgData name="박 성균" userId="475b0f278f8dc192" providerId="LiveId" clId="{700B3B1A-3C87-49B6-A18E-E54677178854}" dt="2023-02-20T09:31:57.954" v="0" actId="47"/>
        <pc:sldMkLst>
          <pc:docMk/>
          <pc:sldMk cId="1372664160" sldId="258"/>
        </pc:sldMkLst>
      </pc:sldChg>
      <pc:sldChg chg="del">
        <pc:chgData name="박 성균" userId="475b0f278f8dc192" providerId="LiveId" clId="{700B3B1A-3C87-49B6-A18E-E54677178854}" dt="2023-02-20T09:31:57.954" v="0" actId="47"/>
        <pc:sldMkLst>
          <pc:docMk/>
          <pc:sldMk cId="2027816751" sldId="259"/>
        </pc:sldMkLst>
      </pc:sldChg>
      <pc:sldChg chg="addSp delSp modSp mod modNotesTx">
        <pc:chgData name="박 성균" userId="475b0f278f8dc192" providerId="LiveId" clId="{700B3B1A-3C87-49B6-A18E-E54677178854}" dt="2023-02-23T05:53:22.099" v="153" actId="1076"/>
        <pc:sldMkLst>
          <pc:docMk/>
          <pc:sldMk cId="3712454426" sldId="260"/>
        </pc:sldMkLst>
        <pc:spChg chg="add mod">
          <ac:chgData name="박 성균" userId="475b0f278f8dc192" providerId="LiveId" clId="{700B3B1A-3C87-49B6-A18E-E54677178854}" dt="2023-02-23T05:53:19.603" v="152" actId="1076"/>
          <ac:spMkLst>
            <pc:docMk/>
            <pc:sldMk cId="3712454426" sldId="260"/>
            <ac:spMk id="2" creationId="{5A59C6DD-A0F0-D1D6-6044-33AA70A95092}"/>
          </ac:spMkLst>
        </pc:spChg>
        <pc:spChg chg="del">
          <ac:chgData name="박 성균" userId="475b0f278f8dc192" providerId="LiveId" clId="{700B3B1A-3C87-49B6-A18E-E54677178854}" dt="2023-02-20T09:31:59.835" v="1" actId="478"/>
          <ac:spMkLst>
            <pc:docMk/>
            <pc:sldMk cId="3712454426" sldId="260"/>
            <ac:spMk id="2" creationId="{ECAA7426-4673-D678-6DAA-9D9378DEBC95}"/>
          </ac:spMkLst>
        </pc:spChg>
        <pc:spChg chg="del mod">
          <ac:chgData name="박 성균" userId="475b0f278f8dc192" providerId="LiveId" clId="{700B3B1A-3C87-49B6-A18E-E54677178854}" dt="2023-02-20T09:32:00.531" v="3" actId="478"/>
          <ac:spMkLst>
            <pc:docMk/>
            <pc:sldMk cId="3712454426" sldId="260"/>
            <ac:spMk id="3" creationId="{50850D1C-2DC5-E38D-05F6-88975C9D97F3}"/>
          </ac:spMkLst>
        </pc:spChg>
        <pc:picChg chg="add mod">
          <ac:chgData name="박 성균" userId="475b0f278f8dc192" providerId="LiveId" clId="{700B3B1A-3C87-49B6-A18E-E54677178854}" dt="2023-02-23T05:53:22.099" v="153" actId="1076"/>
          <ac:picMkLst>
            <pc:docMk/>
            <pc:sldMk cId="3712454426" sldId="260"/>
            <ac:picMk id="4" creationId="{BEE53A1A-C7E2-4E9E-BAE0-81E2079F85E4}"/>
          </ac:picMkLst>
        </pc:picChg>
      </pc:sldChg>
    </pc:docChg>
  </pc:docChgLst>
  <pc:docChgLst>
    <pc:chgData name="박 성균" userId="475b0f278f8dc192" providerId="LiveId" clId="{6EDEF6AF-E6CA-478F-AB82-BC6849DAEB6B}"/>
    <pc:docChg chg="custSel addSld modSld">
      <pc:chgData name="박 성균" userId="475b0f278f8dc192" providerId="LiveId" clId="{6EDEF6AF-E6CA-478F-AB82-BC6849DAEB6B}" dt="2023-01-16T23:55:55.583" v="431" actId="20577"/>
      <pc:docMkLst>
        <pc:docMk/>
      </pc:docMkLst>
      <pc:sldChg chg="new">
        <pc:chgData name="박 성균" userId="475b0f278f8dc192" providerId="LiveId" clId="{6EDEF6AF-E6CA-478F-AB82-BC6849DAEB6B}" dt="2023-01-16T23:48:27.536" v="0" actId="680"/>
        <pc:sldMkLst>
          <pc:docMk/>
          <pc:sldMk cId="1290401223" sldId="256"/>
        </pc:sldMkLst>
      </pc:sldChg>
      <pc:sldChg chg="addSp delSp modSp new mod modNotesTx">
        <pc:chgData name="박 성균" userId="475b0f278f8dc192" providerId="LiveId" clId="{6EDEF6AF-E6CA-478F-AB82-BC6849DAEB6B}" dt="2023-01-16T23:55:55.583" v="431" actId="20577"/>
        <pc:sldMkLst>
          <pc:docMk/>
          <pc:sldMk cId="4146746184" sldId="257"/>
        </pc:sldMkLst>
        <pc:spChg chg="del">
          <ac:chgData name="박 성균" userId="475b0f278f8dc192" providerId="LiveId" clId="{6EDEF6AF-E6CA-478F-AB82-BC6849DAEB6B}" dt="2023-01-16T23:48:37.265" v="4" actId="478"/>
          <ac:spMkLst>
            <pc:docMk/>
            <pc:sldMk cId="4146746184" sldId="257"/>
            <ac:spMk id="2" creationId="{359695BB-1B72-EAE4-B08F-98AA9E70F19C}"/>
          </ac:spMkLst>
        </pc:spChg>
        <pc:spChg chg="add del">
          <ac:chgData name="박 성균" userId="475b0f278f8dc192" providerId="LiveId" clId="{6EDEF6AF-E6CA-478F-AB82-BC6849DAEB6B}" dt="2023-01-16T23:48:38.040" v="5" actId="478"/>
          <ac:spMkLst>
            <pc:docMk/>
            <pc:sldMk cId="4146746184" sldId="257"/>
            <ac:spMk id="3" creationId="{0CBCF121-9EEE-FD29-9F18-DFCBDA9ABD86}"/>
          </ac:spMkLst>
        </pc:spChg>
        <pc:spChg chg="add mod">
          <ac:chgData name="박 성균" userId="475b0f278f8dc192" providerId="LiveId" clId="{6EDEF6AF-E6CA-478F-AB82-BC6849DAEB6B}" dt="2023-01-16T23:52:28.252" v="278" actId="1076"/>
          <ac:spMkLst>
            <pc:docMk/>
            <pc:sldMk cId="4146746184" sldId="257"/>
            <ac:spMk id="5" creationId="{11E51F27-A109-B610-3C90-529B9AC6FC8D}"/>
          </ac:spMkLst>
        </pc:spChg>
        <pc:spChg chg="add mod">
          <ac:chgData name="박 성균" userId="475b0f278f8dc192" providerId="LiveId" clId="{6EDEF6AF-E6CA-478F-AB82-BC6849DAEB6B}" dt="2023-01-16T23:53:41.087" v="310" actId="1038"/>
          <ac:spMkLst>
            <pc:docMk/>
            <pc:sldMk cId="4146746184" sldId="257"/>
            <ac:spMk id="6" creationId="{216FA059-8F9A-48E0-C0D0-C0B61B57277C}"/>
          </ac:spMkLst>
        </pc:spChg>
        <pc:spChg chg="add mod">
          <ac:chgData name="박 성균" userId="475b0f278f8dc192" providerId="LiveId" clId="{6EDEF6AF-E6CA-478F-AB82-BC6849DAEB6B}" dt="2023-01-16T23:52:28.252" v="278" actId="1076"/>
          <ac:spMkLst>
            <pc:docMk/>
            <pc:sldMk cId="4146746184" sldId="257"/>
            <ac:spMk id="7" creationId="{251C2E4C-68D0-0CE9-6919-1DD3FF8892F7}"/>
          </ac:spMkLst>
        </pc:spChg>
        <pc:spChg chg="add mod">
          <ac:chgData name="박 성균" userId="475b0f278f8dc192" providerId="LiveId" clId="{6EDEF6AF-E6CA-478F-AB82-BC6849DAEB6B}" dt="2023-01-16T23:52:28.252" v="278" actId="1076"/>
          <ac:spMkLst>
            <pc:docMk/>
            <pc:sldMk cId="4146746184" sldId="257"/>
            <ac:spMk id="8" creationId="{0DA76F23-98A3-FF9D-F7A4-18AB5EB1892D}"/>
          </ac:spMkLst>
        </pc:spChg>
        <pc:spChg chg="add mod">
          <ac:chgData name="박 성균" userId="475b0f278f8dc192" providerId="LiveId" clId="{6EDEF6AF-E6CA-478F-AB82-BC6849DAEB6B}" dt="2023-01-16T23:53:41.087" v="310" actId="1038"/>
          <ac:spMkLst>
            <pc:docMk/>
            <pc:sldMk cId="4146746184" sldId="257"/>
            <ac:spMk id="9" creationId="{D83AE84C-B419-2FCD-DEAE-89D828B34FE0}"/>
          </ac:spMkLst>
        </pc:spChg>
        <pc:spChg chg="add mod">
          <ac:chgData name="박 성균" userId="475b0f278f8dc192" providerId="LiveId" clId="{6EDEF6AF-E6CA-478F-AB82-BC6849DAEB6B}" dt="2023-01-16T23:53:41.087" v="310" actId="1038"/>
          <ac:spMkLst>
            <pc:docMk/>
            <pc:sldMk cId="4146746184" sldId="257"/>
            <ac:spMk id="10" creationId="{84DD82ED-7BD8-56E3-6F78-F99E604C4A57}"/>
          </ac:spMkLst>
        </pc:spChg>
        <pc:spChg chg="add mod">
          <ac:chgData name="박 성균" userId="475b0f278f8dc192" providerId="LiveId" clId="{6EDEF6AF-E6CA-478F-AB82-BC6849DAEB6B}" dt="2023-01-16T23:55:04.371" v="369" actId="1076"/>
          <ac:spMkLst>
            <pc:docMk/>
            <pc:sldMk cId="4146746184" sldId="257"/>
            <ac:spMk id="17" creationId="{917716E8-9E6D-A09B-5997-7A88997036D5}"/>
          </ac:spMkLst>
        </pc:spChg>
        <pc:spChg chg="add del mod">
          <ac:chgData name="박 성균" userId="475b0f278f8dc192" providerId="LiveId" clId="{6EDEF6AF-E6CA-478F-AB82-BC6849DAEB6B}" dt="2023-01-16T23:52:23.254" v="277"/>
          <ac:spMkLst>
            <pc:docMk/>
            <pc:sldMk cId="4146746184" sldId="257"/>
            <ac:spMk id="18" creationId="{DA38E1C6-3582-17B5-AFCD-490590E0AD3C}"/>
          </ac:spMkLst>
        </pc:spChg>
        <pc:spChg chg="add mod">
          <ac:chgData name="박 성균" userId="475b0f278f8dc192" providerId="LiveId" clId="{6EDEF6AF-E6CA-478F-AB82-BC6849DAEB6B}" dt="2023-01-16T23:55:24.529" v="378" actId="1076"/>
          <ac:spMkLst>
            <pc:docMk/>
            <pc:sldMk cId="4146746184" sldId="257"/>
            <ac:spMk id="22" creationId="{18E77BDD-706D-BA92-98C5-D163BDFA5204}"/>
          </ac:spMkLst>
        </pc:spChg>
        <pc:graphicFrameChg chg="add del mod">
          <ac:chgData name="박 성균" userId="475b0f278f8dc192" providerId="LiveId" clId="{6EDEF6AF-E6CA-478F-AB82-BC6849DAEB6B}" dt="2023-01-16T23:48:35.540" v="3"/>
          <ac:graphicFrameMkLst>
            <pc:docMk/>
            <pc:sldMk cId="4146746184" sldId="257"/>
            <ac:graphicFrameMk id="4" creationId="{76F99DB5-0A89-8B07-30BC-5E2F10A688C1}"/>
          </ac:graphicFrameMkLst>
        </pc:graphicFrameChg>
        <pc:cxnChg chg="add mod">
          <ac:chgData name="박 성균" userId="475b0f278f8dc192" providerId="LiveId" clId="{6EDEF6AF-E6CA-478F-AB82-BC6849DAEB6B}" dt="2023-01-16T23:52:28.252" v="278" actId="1076"/>
          <ac:cxnSpMkLst>
            <pc:docMk/>
            <pc:sldMk cId="4146746184" sldId="257"/>
            <ac:cxnSpMk id="12" creationId="{E3C3EC02-8FC9-E767-2954-5A89A2522272}"/>
          </ac:cxnSpMkLst>
        </pc:cxnChg>
        <pc:cxnChg chg="add mod">
          <ac:chgData name="박 성균" userId="475b0f278f8dc192" providerId="LiveId" clId="{6EDEF6AF-E6CA-478F-AB82-BC6849DAEB6B}" dt="2023-01-16T23:55:31.820" v="380" actId="14100"/>
          <ac:cxnSpMkLst>
            <pc:docMk/>
            <pc:sldMk cId="4146746184" sldId="257"/>
            <ac:cxnSpMk id="13" creationId="{45FB00E6-8B90-14A0-2F1C-435C821CE8B0}"/>
          </ac:cxnSpMkLst>
        </pc:cxnChg>
        <pc:cxnChg chg="add mod">
          <ac:chgData name="박 성균" userId="475b0f278f8dc192" providerId="LiveId" clId="{6EDEF6AF-E6CA-478F-AB82-BC6849DAEB6B}" dt="2023-01-16T23:52:28.252" v="278" actId="1076"/>
          <ac:cxnSpMkLst>
            <pc:docMk/>
            <pc:sldMk cId="4146746184" sldId="257"/>
            <ac:cxnSpMk id="15" creationId="{E7F6253D-4482-D92B-101D-5B9DA72731C5}"/>
          </ac:cxnSpMkLst>
        </pc:cxnChg>
        <pc:cxnChg chg="add mod">
          <ac:chgData name="박 성균" userId="475b0f278f8dc192" providerId="LiveId" clId="{6EDEF6AF-E6CA-478F-AB82-BC6849DAEB6B}" dt="2023-01-16T23:55:35.694" v="382" actId="14100"/>
          <ac:cxnSpMkLst>
            <pc:docMk/>
            <pc:sldMk cId="4146746184" sldId="257"/>
            <ac:cxnSpMk id="16" creationId="{E932FE73-497B-636C-FD0B-187F52A907C0}"/>
          </ac:cxnSpMkLst>
        </pc:cxnChg>
        <pc:cxnChg chg="add mod">
          <ac:chgData name="박 성균" userId="475b0f278f8dc192" providerId="LiveId" clId="{6EDEF6AF-E6CA-478F-AB82-BC6849DAEB6B}" dt="2023-01-16T23:55:04.371" v="369" actId="1076"/>
          <ac:cxnSpMkLst>
            <pc:docMk/>
            <pc:sldMk cId="4146746184" sldId="257"/>
            <ac:cxnSpMk id="19" creationId="{A512CA49-723B-ADF9-81B8-ACC16F29D0E5}"/>
          </ac:cxnSpMkLst>
        </pc:cxnChg>
        <pc:cxnChg chg="add mod">
          <ac:chgData name="박 성균" userId="475b0f278f8dc192" providerId="LiveId" clId="{6EDEF6AF-E6CA-478F-AB82-BC6849DAEB6B}" dt="2023-01-16T23:55:04.371" v="369" actId="1076"/>
          <ac:cxnSpMkLst>
            <pc:docMk/>
            <pc:sldMk cId="4146746184" sldId="257"/>
            <ac:cxnSpMk id="21" creationId="{392EE18C-B7A4-9A91-6C6D-BB39955C0F37}"/>
          </ac:cxnSpMkLst>
        </pc:cxnChg>
        <pc:cxnChg chg="add mod">
          <ac:chgData name="박 성균" userId="475b0f278f8dc192" providerId="LiveId" clId="{6EDEF6AF-E6CA-478F-AB82-BC6849DAEB6B}" dt="2023-01-16T23:55:24.529" v="378" actId="1076"/>
          <ac:cxnSpMkLst>
            <pc:docMk/>
            <pc:sldMk cId="4146746184" sldId="257"/>
            <ac:cxnSpMk id="30" creationId="{E91F082B-FE65-C769-5F18-455257CF570E}"/>
          </ac:cxnSpMkLst>
        </pc:cxnChg>
        <pc:cxnChg chg="add mod">
          <ac:chgData name="박 성균" userId="475b0f278f8dc192" providerId="LiveId" clId="{6EDEF6AF-E6CA-478F-AB82-BC6849DAEB6B}" dt="2023-01-16T23:55:24.529" v="378" actId="1076"/>
          <ac:cxnSpMkLst>
            <pc:docMk/>
            <pc:sldMk cId="4146746184" sldId="257"/>
            <ac:cxnSpMk id="33" creationId="{B180B879-6AB7-9D52-37B9-2B26A1B2625D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9CD7A7-7F77-46B9-94B9-F82F5908B1FB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D0755A-D0B0-4A10-A221-60269284B55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07878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D0755A-D0B0-4A10-A221-60269284B55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9530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B83130-B3B2-B316-A5BE-88DA01AE65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F0E9355-A10C-D72D-4CB1-3C0DFB612E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D3649B-37BC-680C-C938-80541C3BB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B15AB1-1178-2B9E-2162-6DB013A46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114CC3D-F2A3-2AB9-5B43-FBC646EC7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4524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2BF694-1A54-D3F5-CBC4-CA57BCBF07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C588CA1-6517-25DC-BC23-32C3252E6E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89FF7C-8459-9AD6-6F2E-E952F80F5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795CBB9-0539-B8A8-30CF-52748CF34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D0A770D-8854-FAFC-03FF-BB5E734D5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0992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3E51AE4-B575-90F0-E089-D9D3DBB61C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C73B574-C687-633C-BCE2-B232A1B41E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448349F-CDDE-3399-1F8C-24A6941FB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025C38-C95C-545B-530F-9A4E406EA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A66722-B4C3-5300-07C1-0A3F290BE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832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19A7317-A2D0-BC42-F624-4669238956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114CF6F-D648-0508-9586-30F50B5D86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A37514E-B77B-F1F9-FCAD-E428DF515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610983-7438-06C2-DDA3-888DA4331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4C37A2A-D871-581F-A989-BC85B25D8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9761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C3DA2ED-2022-CD64-3F92-3D15C1D90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EE72FF0-C1A6-A699-258F-499DB63698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E1F9B61-D0EA-57E4-DBB5-7BF35E39D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586815E-2DBA-00E7-FEB1-850448412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71C6B7B-51A7-EC64-E258-09E407A6E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8000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55C245-0C17-2EF5-0A84-518FE3734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990281C-5F65-554E-CD3C-EB903BD9FD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89F82DF-CDC0-64A7-25B8-730325BDF2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265984F-B5EC-63C8-D0A7-E9089B0AF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6132198-D9B8-BA95-933F-F68EE5722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6F9AA31-9A14-F9E7-60A2-B364E0D2C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968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0EA984-6B55-644F-6813-69D5E0BCCC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648703E-03D2-0148-5283-49F6A29A44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0F60B1A-AD08-FEB3-399F-8302F51741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258EB26-A6ED-AE20-3D40-05BA9E01B0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8953055-2477-7DD8-817B-BD0FDE296E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0A38A1B-4AB4-F924-5BF9-5CBC94987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2724DEE2-B1F9-6E66-C990-8A42C9676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EB7B78F-A95F-FCC2-9B12-5A674B5ED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961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CA29B9-3D3C-C1A1-9367-630F6D404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0C40FB3-DC42-5FA0-E138-D10DB4B4E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FD4C02BF-0380-5870-9209-388F2F93E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FF735D4-375E-B4FE-236D-ADB62EE79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5474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F08C802-6F0B-5726-0639-EBC80CFFB6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68D07D6-32CD-0001-22C5-C9EDF4DEB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EEAE9F5-836D-42E3-44DE-ACEF464E1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6131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32581C8-60EA-3A18-2307-2D1867053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CD9E82D-79B9-E091-F67B-7830E94B77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D765CD7-056F-D160-BCBA-D3D86CE42E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0C9944F-D05E-E43D-E0F5-C67C38C75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49049EA-3674-D3B3-748C-838A8A114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887D79-3BA1-F2BB-ED2A-75DD303F5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539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D8D9A69-168C-E619-7C3B-0284FEBB6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A9CB12C-4AE1-E4BD-BF3D-B16AE9E724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DE4F8E7-992F-23C0-AD59-DBE8A81592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8458AF7-A213-5242-CC96-59C3129C8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B1CE404-5D24-3EBA-05AA-6BA96AF2A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87F7FE0-C22F-B637-9DBF-96ECF0FE3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0284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57C1684F-8DBC-A07D-2788-0538577804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73A13E7-8CE8-FE0F-1041-7C8385173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8A7D29-CB3D-E82F-C255-D0B2EE4E3F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DB6768-C776-4F6B-9598-9ED30E09F432}" type="datetimeFigureOut">
              <a:rPr lang="ko-KR" altLang="en-US" smtClean="0"/>
              <a:t>2023-06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3157D09-8802-D00E-0495-929407A807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BCABE9B-3B40-C541-A1E7-C36D0E3AB4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EB6D6D-22E4-4C53-A6FF-A7C474E8FB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0472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BEE53A1A-C7E2-4E9E-BAE0-81E2079F85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2289" y="-181124"/>
            <a:ext cx="5827421" cy="661910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A59C6DD-A0F0-D1D6-6044-33AA70A95092}"/>
              </a:ext>
            </a:extLst>
          </p:cNvPr>
          <p:cNvSpPr txBox="1"/>
          <p:nvPr/>
        </p:nvSpPr>
        <p:spPr>
          <a:xfrm>
            <a:off x="684070" y="6437977"/>
            <a:ext cx="115939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/>
              <a:t>Figure S1</a:t>
            </a:r>
            <a:r>
              <a:rPr lang="en-US" altLang="ko-KR" dirty="0"/>
              <a:t>. Difference between height-based volume and inoculated volume in aerobic and anaerobic bottles</a:t>
            </a:r>
            <a:endParaRPr lang="ko-KR" altLang="en-US" dirty="0"/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12454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</TotalTime>
  <Words>16</Words>
  <Application>Microsoft Office PowerPoint</Application>
  <PresentationFormat>와이드스크린</PresentationFormat>
  <Paragraphs>2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성균</dc:creator>
  <cp:lastModifiedBy>박 성균</cp:lastModifiedBy>
  <cp:revision>1</cp:revision>
  <dcterms:created xsi:type="dcterms:W3CDTF">2023-01-16T23:48:25Z</dcterms:created>
  <dcterms:modified xsi:type="dcterms:W3CDTF">2023-06-07T01:40:15Z</dcterms:modified>
</cp:coreProperties>
</file>